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6858000" cy="9144000"/>
  <p:notesSz cx="7315200" cy="96012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708B13-D656-4203-8FA0-64C1910BECAE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2F28F1C-474A-4503-99FE-0B63EC5B93B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F9E8F19-C38B-4A97-B297-A33055042FC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38FFF69-0769-4373-A656-740067F0A0EA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3266702-69B6-4794-BAD1-D6F297061D83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4BA1C2A-119B-48C7-BA38-44938BF58EC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E2FC83C-3AE3-4225-8622-55E58A55177E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6DA241C-498F-4670-BC10-C690208D142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1C2EFAC-0310-4A30-9305-C50EC74CF6E7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15BB1C-5A0C-4D04-B4B3-4C2534698CF7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1A5A7E2-808C-4B1E-BA22-2AD70D59430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70D43E6-BFF5-48B3-8CBC-A71DCC88B92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Arial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Arial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326440"/>
            <a:ext cx="217152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326440"/>
            <a:ext cx="1600200" cy="63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it-IT" sz="1400" spc="-1" strike="noStrike">
                <a:solidFill>
                  <a:srgbClr val="000000"/>
                </a:solidFill>
                <a:latin typeface="Arial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07DBE61-88FB-4AFE-9CC1-FA1AC35A4249}" type="slidenum">
              <a:rPr b="0" lang="it-IT" sz="1400" spc="-1" strike="noStrike">
                <a:solidFill>
                  <a:srgbClr val="000000"/>
                </a:solidFill>
                <a:latin typeface="Arial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404640" y="6365880"/>
            <a:ext cx="35290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spcBef>
                <a:spcPts val="300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*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Values are Mean </a:t>
            </a:r>
            <a:r>
              <a:rPr b="0" lang="en-US" sz="1200" spc="-1" strike="noStrike">
                <a:solidFill>
                  <a:srgbClr val="000000"/>
                </a:solidFill>
                <a:latin typeface="Arial"/>
                <a:ea typeface="Arial"/>
              </a:rPr>
              <a:t>± Standard deviation; </a:t>
            </a:r>
            <a:r>
              <a:rPr b="0" lang="it-IT" sz="1200" spc="-1" strike="noStrike">
                <a:solidFill>
                  <a:srgbClr val="000000"/>
                </a:solidFill>
                <a:latin typeface="Arial"/>
              </a:rPr>
              <a:t>n=6.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graphicFrame>
        <p:nvGraphicFramePr>
          <p:cNvPr id="42" name=""/>
          <p:cNvGraphicFramePr/>
          <p:nvPr/>
        </p:nvGraphicFramePr>
        <p:xfrm>
          <a:off x="333360" y="2554200"/>
          <a:ext cx="6200640" cy="1284480"/>
        </p:xfrm>
        <a:graphic>
          <a:graphicData uri="http://schemas.openxmlformats.org/drawingml/2006/table">
            <a:tbl>
              <a:tblPr/>
              <a:tblGrid>
                <a:gridCol w="792000"/>
                <a:gridCol w="1976760"/>
                <a:gridCol w="1911240"/>
                <a:gridCol w="1520640"/>
              </a:tblGrid>
              <a:tr h="5220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T strain 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fin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  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 initi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DR052C (</a:t>
                      </a:r>
                      <a:r>
                        <a:rPr b="0" i="1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DBF4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fin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  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 initi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 value (two-way ANOVA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58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ntre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06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17 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034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11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66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B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10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23 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921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13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6.41 x 10</a:t>
                      </a:r>
                      <a:r>
                        <a:rPr b="0" lang="it-IT" sz="1200" spc="-1" strike="noStrike" baseline="30000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-6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graphicFrame>
        <p:nvGraphicFramePr>
          <p:cNvPr id="43" name=""/>
          <p:cNvGraphicFramePr/>
          <p:nvPr/>
        </p:nvGraphicFramePr>
        <p:xfrm>
          <a:off x="396720" y="4722840"/>
          <a:ext cx="6120000" cy="1284120"/>
        </p:xfrm>
        <a:graphic>
          <a:graphicData uri="http://schemas.openxmlformats.org/drawingml/2006/table">
            <a:tbl>
              <a:tblPr/>
              <a:tblGrid>
                <a:gridCol w="800280"/>
                <a:gridCol w="1928880"/>
                <a:gridCol w="1887480"/>
                <a:gridCol w="1503360"/>
              </a:tblGrid>
              <a:tr h="52200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WT strain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fin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  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 initi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YNL148C (</a:t>
                      </a:r>
                      <a:r>
                        <a:rPr b="0" i="1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ALF1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(fin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  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- initial OD</a:t>
                      </a:r>
                      <a:r>
                        <a:rPr b="0" lang="it-IT" sz="1200" spc="-1" strike="noStrike" baseline="-25000">
                          <a:solidFill>
                            <a:srgbClr val="000000"/>
                          </a:solidFill>
                          <a:latin typeface="Times New Roman"/>
                        </a:rPr>
                        <a:t>600</a:t>
                      </a: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p value (two-way ANOVA)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41544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Untreated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05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03 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1.115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20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endParaRPr b="0" lang="en-US" sz="18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  <a:tr h="346680"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IBA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889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22 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</a:rPr>
                        <a:t>0.829 </a:t>
                      </a:r>
                      <a:r>
                        <a:rPr b="0" lang="en-US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± 0.004*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  <a:tc>
                  <a:txBody>
                    <a:bodyPr lIns="90000" rIns="90000" tIns="46800" bIns="46800" anchor="ctr" anchorCtr="1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spcBef>
                          <a:spcPts val="300"/>
                        </a:spcBef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it-IT" sz="1200" spc="-1" strike="noStrike">
                          <a:solidFill>
                            <a:srgbClr val="000000"/>
                          </a:solidFill>
                          <a:latin typeface="Times New Roman"/>
                          <a:ea typeface="Arial"/>
                        </a:rPr>
                        <a:t>0.0043</a:t>
                      </a:r>
                      <a:endParaRPr b="0" lang="en-US" sz="1200" spc="-1" strike="noStrike">
                        <a:solidFill>
                          <a:srgbClr val="000000"/>
                        </a:solidFill>
                        <a:latin typeface="Arial"/>
                      </a:endParaRPr>
                    </a:p>
                  </a:txBody>
                  <a:tcPr anchor="ctr" marL="90000" marR="90000">
                    <a:lnL w="5760">
                      <a:solidFill>
                        <a:srgbClr val="000000"/>
                      </a:solidFill>
                    </a:lnL>
                    <a:lnR w="5760">
                      <a:solidFill>
                        <a:srgbClr val="000000"/>
                      </a:solidFill>
                    </a:lnR>
                    <a:lnT w="5760">
                      <a:solidFill>
                        <a:srgbClr val="000000"/>
                      </a:solidFill>
                    </a:lnT>
                    <a:lnB w="5760">
                      <a:solidFill>
                        <a:srgbClr val="000000"/>
                      </a:solidFill>
                    </a:lnB>
                    <a:noFill/>
                  </a:tcPr>
                </a:tc>
              </a:tr>
            </a:tbl>
          </a:graphicData>
        </a:graphic>
      </p:graphicFrame>
      <p:sp>
        <p:nvSpPr>
          <p:cNvPr id="44" name=""/>
          <p:cNvSpPr/>
          <p:nvPr/>
        </p:nvSpPr>
        <p:spPr>
          <a:xfrm>
            <a:off x="333360" y="2195640"/>
            <a:ext cx="30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A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5" name=""/>
          <p:cNvSpPr/>
          <p:nvPr/>
        </p:nvSpPr>
        <p:spPr>
          <a:xfrm>
            <a:off x="333360" y="4307040"/>
            <a:ext cx="308160" cy="3373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Arial"/>
              </a:rPr>
              <a:t>B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6" name=""/>
          <p:cNvSpPr/>
          <p:nvPr/>
        </p:nvSpPr>
        <p:spPr>
          <a:xfrm>
            <a:off x="260280" y="1258920"/>
            <a:ext cx="6264360" cy="8240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GB" sz="1600" spc="-1" strike="noStrike">
                <a:solidFill>
                  <a:srgbClr val="000000"/>
                </a:solidFill>
                <a:latin typeface="Times New Roman"/>
              </a:rPr>
              <a:t>Table S5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: Growth data and two-way ANOVA of the wild-type strain (WT) and the hemizygote mutants </a:t>
            </a:r>
            <a:r>
              <a:rPr b="0" i="1" lang="en-GB" sz="1600" spc="-1" strike="noStrike">
                <a:solidFill>
                  <a:srgbClr val="000000"/>
                </a:solidFill>
                <a:latin typeface="Times New Roman"/>
              </a:rPr>
              <a:t>DBF4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 (A) and </a:t>
            </a:r>
            <a:r>
              <a:rPr b="0" i="1" lang="en-GB" sz="1600" spc="-1" strike="noStrike">
                <a:solidFill>
                  <a:srgbClr val="000000"/>
                </a:solidFill>
                <a:latin typeface="Times New Roman"/>
              </a:rPr>
              <a:t>ALF1</a:t>
            </a:r>
            <a:r>
              <a:rPr b="0" lang="en-GB" sz="1600" spc="-1" strike="noStrike">
                <a:solidFill>
                  <a:srgbClr val="000000"/>
                </a:solidFill>
                <a:latin typeface="Times New Roman"/>
              </a:rPr>
              <a:t> (B) in presence and absence of the drug ibandronate (IBA).  </a:t>
            </a:r>
            <a:endParaRPr b="0" lang="en-US" sz="16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541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6-20T09:04:50Z</dcterms:created>
  <dc:creator>Nicoletta Bivi</dc:creator>
  <dc:description/>
  <dc:language>en-US</dc:language>
  <cp:lastModifiedBy>Daniela</cp:lastModifiedBy>
  <dcterms:modified xsi:type="dcterms:W3CDTF">2009-07-16T13:45:51Z</dcterms:modified>
  <cp:revision>38</cp:revision>
  <dc:subject/>
  <dc:title>Slide 1</dc:title>
</cp:coreProperties>
</file>